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9294813" cy="7008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F66DF8-A92C-4751-9CF1-B7A13D2D23B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F87B25-4424-4A47-BF29-0214E93BB9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2938B1-4111-4112-977C-8FEC26583EE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2DA607-7BF4-4D43-B548-1840C42EE43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652E85-AB1A-48EC-A448-6F8B2A08BF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73DD16-1672-4ACA-8616-E88AEFD611F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44E334-B3BB-4A06-9215-0AE821C9FA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7BDDBF-4DEA-4AF8-946F-98F8B00B679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F2C935-5457-4875-816B-99AB22FDBD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66A2B4-E2C6-41F9-8919-9B9AE05CC1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7A365C-B465-4101-9E14-9299E7419B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F2094D-A960-46B1-AD14-B8B5286DEB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C3D7684-5FB5-4537-B067-FA0D227F766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itle 18"/>
          <p:cNvSpPr/>
          <p:nvPr/>
        </p:nvSpPr>
        <p:spPr>
          <a:xfrm>
            <a:off x="297000" y="3786120"/>
            <a:ext cx="8442360" cy="60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Additional Figure S2. Individual Sanger Sequenced BACs aligned to 454 pseudomolecule.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hown are MUMMER plots of individual Sanger-sequenced BAC assemblies mostly match with corrected 35L-15PP 454 pseudomolecule.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1" descr=""/>
          <p:cNvPicPr/>
          <p:nvPr/>
        </p:nvPicPr>
        <p:blipFill>
          <a:blip r:embed="rId1"/>
          <a:srcRect l="31147" t="22335" r="13960" b="49167"/>
          <a:stretch/>
        </p:blipFill>
        <p:spPr>
          <a:xfrm>
            <a:off x="297000" y="847800"/>
            <a:ext cx="8453160" cy="2743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2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18T20:19:09Z</dcterms:created>
  <dc:creator>Christopher Saski</dc:creator>
  <dc:description/>
  <dc:language>en-US</dc:language>
  <cp:lastModifiedBy>feltus</cp:lastModifiedBy>
  <cp:lastPrinted>2011-01-13T19:51:43Z</cp:lastPrinted>
  <dcterms:modified xsi:type="dcterms:W3CDTF">2011-04-04T18:41:14Z</dcterms:modified>
  <cp:revision>145</cp:revision>
  <dc:subject/>
  <dc:title>Pilot Project Update:</dc:title>
</cp:coreProperties>
</file>